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1" d="100"/>
          <a:sy n="41" d="100"/>
        </p:scale>
        <p:origin x="808" y="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5A60E5-47BD-436E-93E5-7199163605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EE21710-7667-4A17-B1CF-0CAA706D98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1C231C-72CE-4764-A92E-182ED169E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AB74C6-FBCA-441C-9310-DB7337C03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C8D1CF-8E68-469D-8783-6321B500E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12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A7D617-774D-40E6-BD45-3CBEFDF4A0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09FB8C-D369-4441-9B38-E7B048DCB6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76C7D0-992D-4001-BD9E-E9192E453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F0889A-C6FF-4373-BAEE-255E8E5A4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A4F7BD-E8CA-4289-B829-4D6AF70FAA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4046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01CEAFD-04F0-469E-82CE-7B0D262554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DD92DA-2C25-4F59-A966-84D4E663E9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0CD154-4282-4415-A742-5B07CE107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11797D-DC80-4FD0-BC96-87264BFC9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4ED23C-D2FC-4D67-9862-43D7DAEE46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2310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F5F92F-B92A-4677-B0D2-65D6913AE3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8671C1-846F-4F0D-9254-209C925FAF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9F120D-4FBA-4D3B-8EDF-1442BD901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28E460-E86B-43E7-8EBC-AA6A07E29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CD77EC-FE7B-4A95-A468-32D9843DE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8818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4646A1-E8C9-4E9B-8329-0BFE1E1437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672D84-85CD-4F17-8670-C38F5D7A95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BDCB0F-8AE0-403D-8F03-7C3907038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B410F1-DC6B-43CB-A183-539A5E775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F82832-341F-491C-A527-20CBB4BA4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0145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1ECDCC-EDE6-44D8-8063-82A20ADCB5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A397F7-E816-4AD5-BC10-5EB06BA2E9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8E1B82-8671-4762-A047-29C6F4EF70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501962-DA8F-4FD6-B6D1-A70CD64B8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DBA539-5111-430A-B6D1-1E340974E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6CA2B7-58D0-4FBE-A30B-903B4CC0C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1817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604C79-4089-495A-BB3B-F3317404C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576A5A-4A98-4045-9740-725F8231A5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C5D226-D2E9-433A-94CF-0A8DC9B6D6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2DD243-41C4-48F5-930E-4E43C19EBD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76A44A-72CA-4500-8B04-0647B0C957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525FA1-0992-4B97-BCB5-6902FCBB4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A211787-6039-4BEE-B3BE-C1E4250C7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EC3B78A-BF73-4C5E-B128-F2C2C69B7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1340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3DDBB4-5BA0-4972-BCF9-D624FB0EF4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2FFEF4-FC08-4C40-B696-F4A6431D6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99414E-8DAC-4A72-98D9-2713502A9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29F1661-38D9-4F31-8C54-45527937E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948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5FAF5A-2FF1-4083-8AF2-DFFC68D50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695255-4085-422D-8D4B-F1A4438AA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AC3FB2-5D78-4067-B912-DECC07D5C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2766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DAC8BD-B830-483F-A18C-D242B428CC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35777E-3F10-457F-ABE2-6FFCFCABDA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7C16A9-08CF-4182-974C-FCFEB38F6F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8E12F7-F553-4CC8-8997-9BB172287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F14923-92EA-4F1B-AE90-41B5DA38B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B41697-11ED-464B-9991-219DC98AD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6450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EAEDF8-2678-452A-B9A9-A66EF0275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4657A6-6AB6-4A44-97AF-52AD5C0C42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8F525A-30A8-4403-9C03-4A74232082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6DDAD6-45B8-4AF0-9FC7-DE7520032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1227A8-1A0D-4043-82D7-678D88779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FC47CB-BB55-48DB-BEA2-86E051799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4932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832B06-E5C9-4EE7-B256-A667D4F10D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5F78C0-0DAB-4A4C-9191-DAF725F3BD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642F0-EA7A-4E0B-86EF-4651ABFAC0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42CAA-5EA0-4810-8DF0-36790D75142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1CEF31-6903-4489-9E25-2BB9DE82FF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298FE1-4015-4489-9589-A205BD1978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EC4AC-4001-4535-9790-FA487D9A7F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661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37241E-8422-4D19-A1B9-29F3647CB37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4988BD-7FD1-43A8-9539-636E9D3C698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11699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8E5E4C67-9B6A-4CC6-BF53-8FE57DB182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113722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6A2C47FA-71E9-45EC-8298-60607BE7FB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778281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BF4372FF-CEF0-420D-AC6A-23E754DB62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846931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6D39923D-D556-4C03-9FCE-DCAE996935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23392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sky, indoor, desk&#10;&#10;Description automatically generated">
            <a:extLst>
              <a:ext uri="{FF2B5EF4-FFF2-40B4-BE49-F238E27FC236}">
                <a16:creationId xmlns:a16="http://schemas.microsoft.com/office/drawing/2014/main" id="{1EBD133C-885E-45B1-AF14-92A01AC657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391304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imeline&#10;&#10;Description automatically generated">
            <a:extLst>
              <a:ext uri="{FF2B5EF4-FFF2-40B4-BE49-F238E27FC236}">
                <a16:creationId xmlns:a16="http://schemas.microsoft.com/office/drawing/2014/main" id="{EBA8EDC0-3D7B-4938-B9E1-26DE904596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85305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fferent&#10;&#10;Description automatically generated">
            <a:extLst>
              <a:ext uri="{FF2B5EF4-FFF2-40B4-BE49-F238E27FC236}">
                <a16:creationId xmlns:a16="http://schemas.microsoft.com/office/drawing/2014/main" id="{B2120CCC-00C2-4E10-A163-C1FDD1ED59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961265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20974148-D6A6-47F3-A5D9-45E26FA19C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467929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9E1E4B30-DA8F-4A6E-AEAB-01A8025C55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893798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00216641-B260-49B4-97E3-B61387B78C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6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667F95FA-B7F3-4BA4-9EE9-35BB8AF50A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338449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imeline&#10;&#10;Description automatically generated">
            <a:extLst>
              <a:ext uri="{FF2B5EF4-FFF2-40B4-BE49-F238E27FC236}">
                <a16:creationId xmlns:a16="http://schemas.microsoft.com/office/drawing/2014/main" id="{55A312A4-9691-443F-BF5E-A5B8246839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050219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imeline&#10;&#10;Description automatically generated">
            <a:extLst>
              <a:ext uri="{FF2B5EF4-FFF2-40B4-BE49-F238E27FC236}">
                <a16:creationId xmlns:a16="http://schemas.microsoft.com/office/drawing/2014/main" id="{35287F00-3C7C-4E33-BFEB-8809A5C3C0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189700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imeline&#10;&#10;Description automatically generated">
            <a:extLst>
              <a:ext uri="{FF2B5EF4-FFF2-40B4-BE49-F238E27FC236}">
                <a16:creationId xmlns:a16="http://schemas.microsoft.com/office/drawing/2014/main" id="{E909A0BA-E2E4-4975-A221-6AD51BD72D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346184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imeline&#10;&#10;Description automatically generated">
            <a:extLst>
              <a:ext uri="{FF2B5EF4-FFF2-40B4-BE49-F238E27FC236}">
                <a16:creationId xmlns:a16="http://schemas.microsoft.com/office/drawing/2014/main" id="{79014F06-5B49-49B6-86FF-CF6D0A052D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979991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diagram, box and whisker chart&#10;&#10;Description automatically generated">
            <a:extLst>
              <a:ext uri="{FF2B5EF4-FFF2-40B4-BE49-F238E27FC236}">
                <a16:creationId xmlns:a16="http://schemas.microsoft.com/office/drawing/2014/main" id="{213C0C27-625E-4D4F-A715-D6242FDFB2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660778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81F6D68F-7231-4664-B00B-DF841A2012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542342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A9B0F320-FFE6-415D-AF2A-E4270964EA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0"/>
            <a:ext cx="10287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670116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box and whisker chart&#10;&#10;Description automatically generated">
            <a:extLst>
              <a:ext uri="{FF2B5EF4-FFF2-40B4-BE49-F238E27FC236}">
                <a16:creationId xmlns:a16="http://schemas.microsoft.com/office/drawing/2014/main" id="{A41871F2-DED1-4C76-9E60-3E2E27AB01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0"/>
            <a:ext cx="10287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764697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A980CC14-DDB1-45DA-815E-42FE634BE4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0"/>
            <a:ext cx="10287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61517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25F71B0E-29E4-445A-BA2C-130EBE54D4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51000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C6083E84-D7FA-4C02-B546-F789FC4605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4990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CC24F84B-F2A4-4FDA-B2CB-E1C9735238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96641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72AC5D21-96C3-4B2C-B001-9CFEEB9145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93352"/>
            <a:ext cx="12192000" cy="38712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12127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9556D116-08DA-44F9-8F9C-0D3999F352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93724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EE511747-6376-4F8E-82A2-C7A3731BDE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62805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FECFE7CB-75ED-431D-9E9E-ACDFE1A9D7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89" y="685794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6578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0</Words>
  <Application>Microsoft Office PowerPoint</Application>
  <PresentationFormat>Widescreen</PresentationFormat>
  <Paragraphs>0</Paragraphs>
  <Slides>2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3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ublic Health Eng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ene Bassano</dc:creator>
  <cp:lastModifiedBy>Irene Bassano</cp:lastModifiedBy>
  <cp:revision>1</cp:revision>
  <dcterms:created xsi:type="dcterms:W3CDTF">2022-09-22T12:03:35Z</dcterms:created>
  <dcterms:modified xsi:type="dcterms:W3CDTF">2022-09-22T12:07:39Z</dcterms:modified>
</cp:coreProperties>
</file>